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07" r:id="rId2"/>
  </p:sldIdLst>
  <p:sldSz cx="6858000" cy="9906000" type="A4"/>
  <p:notesSz cx="9931400" cy="67945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10" userDrawn="1">
          <p15:clr>
            <a:srgbClr val="A4A3A4"/>
          </p15:clr>
        </p15:guide>
        <p15:guide id="2" pos="391" userDrawn="1">
          <p15:clr>
            <a:srgbClr val="A4A3A4"/>
          </p15:clr>
        </p15:guide>
        <p15:guide id="6" orient="horz" pos="6136" userDrawn="1">
          <p15:clr>
            <a:srgbClr val="A4A3A4"/>
          </p15:clr>
        </p15:guide>
        <p15:guide id="7" pos="3884" userDrawn="1">
          <p15:clr>
            <a:srgbClr val="A4A3A4"/>
          </p15:clr>
        </p15:guide>
        <p15:guide id="8" orient="horz" pos="443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E09670F-CE05-9C7F-2A18-F12607C6DEEE}" name="Eva Herrero Serrano" initials="EHS" userId="S::eh642@cam.ac.uk::30ee73c8-4441-48c1-9b41-6efa0a64ae52" providerId="AD"/>
  <p188:author id="{14A239CE-EE99-779E-A9A8-70BD1B86BCFC}" name="Alex Webb" initials="AW" userId="S::aarw2@cam.ac.uk::6e034127-e0df-4368-bc35-fbdfd215004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D92"/>
    <a:srgbClr val="163E62"/>
    <a:srgbClr val="4C95D9"/>
    <a:srgbClr val="46B1E1"/>
    <a:srgbClr val="7A81FF"/>
    <a:srgbClr val="0432FF"/>
    <a:srgbClr val="163E63"/>
    <a:srgbClr val="FF8AD8"/>
    <a:srgbClr val="ECECEC"/>
    <a:srgbClr val="4D95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80" d="100"/>
          <a:sy n="80" d="100"/>
        </p:scale>
        <p:origin x="3576" y="192"/>
      </p:cViewPr>
      <p:guideLst>
        <p:guide orient="horz" pos="1510"/>
        <p:guide pos="391"/>
        <p:guide orient="horz" pos="6136"/>
        <p:guide pos="3884"/>
        <p:guide orient="horz" pos="44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va Herrero Serrano" userId="30ee73c8-4441-48c1-9b41-6efa0a64ae52" providerId="ADAL" clId="{D637D1D2-44F8-5241-8321-286CB27A6976}"/>
    <pc:docChg chg="delSld">
      <pc:chgData name="Eva Herrero Serrano" userId="30ee73c8-4441-48c1-9b41-6efa0a64ae52" providerId="ADAL" clId="{D637D1D2-44F8-5241-8321-286CB27A6976}" dt="2025-07-02T13:31:54.661" v="6" actId="2696"/>
      <pc:docMkLst>
        <pc:docMk/>
      </pc:docMkLst>
      <pc:sldChg chg="del">
        <pc:chgData name="Eva Herrero Serrano" userId="30ee73c8-4441-48c1-9b41-6efa0a64ae52" providerId="ADAL" clId="{D637D1D2-44F8-5241-8321-286CB27A6976}" dt="2025-07-02T13:31:50.041" v="0" actId="2696"/>
        <pc:sldMkLst>
          <pc:docMk/>
          <pc:sldMk cId="328607546" sldId="384"/>
        </pc:sldMkLst>
      </pc:sldChg>
      <pc:sldChg chg="del">
        <pc:chgData name="Eva Herrero Serrano" userId="30ee73c8-4441-48c1-9b41-6efa0a64ae52" providerId="ADAL" clId="{D637D1D2-44F8-5241-8321-286CB27A6976}" dt="2025-07-02T13:31:54.661" v="6" actId="2696"/>
        <pc:sldMkLst>
          <pc:docMk/>
          <pc:sldMk cId="2380616195" sldId="400"/>
        </pc:sldMkLst>
      </pc:sldChg>
      <pc:sldChg chg="del">
        <pc:chgData name="Eva Herrero Serrano" userId="30ee73c8-4441-48c1-9b41-6efa0a64ae52" providerId="ADAL" clId="{D637D1D2-44F8-5241-8321-286CB27A6976}" dt="2025-07-02T13:31:50.515" v="1" actId="2696"/>
        <pc:sldMkLst>
          <pc:docMk/>
          <pc:sldMk cId="548085851" sldId="404"/>
        </pc:sldMkLst>
      </pc:sldChg>
      <pc:sldChg chg="del">
        <pc:chgData name="Eva Herrero Serrano" userId="30ee73c8-4441-48c1-9b41-6efa0a64ae52" providerId="ADAL" clId="{D637D1D2-44F8-5241-8321-286CB27A6976}" dt="2025-07-02T13:31:54.101" v="5" actId="2696"/>
        <pc:sldMkLst>
          <pc:docMk/>
          <pc:sldMk cId="2941851669" sldId="406"/>
        </pc:sldMkLst>
      </pc:sldChg>
      <pc:sldChg chg="del">
        <pc:chgData name="Eva Herrero Serrano" userId="30ee73c8-4441-48c1-9b41-6efa0a64ae52" providerId="ADAL" clId="{D637D1D2-44F8-5241-8321-286CB27A6976}" dt="2025-07-02T13:31:51.863" v="2" actId="2696"/>
        <pc:sldMkLst>
          <pc:docMk/>
          <pc:sldMk cId="2384589629" sldId="408"/>
        </pc:sldMkLst>
      </pc:sldChg>
      <pc:sldChg chg="del">
        <pc:chgData name="Eva Herrero Serrano" userId="30ee73c8-4441-48c1-9b41-6efa0a64ae52" providerId="ADAL" clId="{D637D1D2-44F8-5241-8321-286CB27A6976}" dt="2025-07-02T13:31:53.408" v="4" actId="2696"/>
        <pc:sldMkLst>
          <pc:docMk/>
          <pc:sldMk cId="2625866172" sldId="409"/>
        </pc:sldMkLst>
      </pc:sldChg>
      <pc:sldChg chg="del">
        <pc:chgData name="Eva Herrero Serrano" userId="30ee73c8-4441-48c1-9b41-6efa0a64ae52" providerId="ADAL" clId="{D637D1D2-44F8-5241-8321-286CB27A6976}" dt="2025-07-02T13:31:52.836" v="3" actId="2696"/>
        <pc:sldMkLst>
          <pc:docMk/>
          <pc:sldMk cId="564929238" sldId="41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5497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0B9EA6-4523-204F-A38C-EB310BB9E6E6}" type="datetimeFigureOut">
              <a:rPr lang="en-US" smtClean="0"/>
              <a:t>7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71950" y="849313"/>
            <a:ext cx="1587500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3140" y="3269853"/>
            <a:ext cx="7945120" cy="2675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5497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65B47-02A3-6545-81BD-CE096AC3AC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9780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0749-87E1-654D-9347-98A262523D99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66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A369A-2B05-6844-B0A9-E549CABD4D18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881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2C1AE-F068-A54F-BD59-F157D26CAF3B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038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A49AF-D4B1-B841-A3C6-0797BAE97B73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735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EC4B1-A988-4D40-8895-309A5922874F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504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28266-E031-EE4A-AA5B-25E86C1B8835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672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81142-A245-CD4C-98EC-FE91F66445E5}" type="datetime1">
              <a:rPr lang="en-GB" smtClean="0"/>
              <a:t>02/0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482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AF423-F805-2041-97CC-1A4994037567}" type="datetime1">
              <a:rPr lang="en-GB" smtClean="0"/>
              <a:t>02/0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45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91740-F340-7F42-A214-B550E62E5598}" type="datetime1">
              <a:rPr lang="en-GB" smtClean="0"/>
              <a:t>02/0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2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1EBA1-5261-ED4A-BA40-688502E8C4F1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586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8212F-31D4-CC4E-BBE9-0FE5E46009E3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61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6F5EBD4-D993-2F4A-BC64-32375B140610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563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81FE001-74F3-6217-94D7-7FDB13F4DDB2}"/>
              </a:ext>
            </a:extLst>
          </p:cNvPr>
          <p:cNvSpPr txBox="1"/>
          <p:nvPr/>
        </p:nvSpPr>
        <p:spPr>
          <a:xfrm>
            <a:off x="251686" y="192224"/>
            <a:ext cx="4609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Extended data Figure 3. LWD1-Venus complementation lines</a:t>
            </a:r>
            <a:endParaRPr lang="en-US" i="1"/>
          </a:p>
        </p:txBody>
      </p:sp>
      <p:pic>
        <p:nvPicPr>
          <p:cNvPr id="2" name="Graphic 1">
            <a:extLst>
              <a:ext uri="{FF2B5EF4-FFF2-40B4-BE49-F238E27FC236}">
                <a16:creationId xmlns:a16="http://schemas.microsoft.com/office/drawing/2014/main" id="{FF8679B5-49AB-8179-8C15-3D21E18814D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29587" t="12289" r="22920" b="29515"/>
          <a:stretch/>
        </p:blipFill>
        <p:spPr>
          <a:xfrm>
            <a:off x="330925" y="644434"/>
            <a:ext cx="3257007" cy="2603863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E0D17B72-670B-10A6-A718-7CF602E5D3FA}"/>
              </a:ext>
            </a:extLst>
          </p:cNvPr>
          <p:cNvGrpSpPr/>
          <p:nvPr/>
        </p:nvGrpSpPr>
        <p:grpSpPr>
          <a:xfrm>
            <a:off x="3779586" y="622435"/>
            <a:ext cx="2592147" cy="2647860"/>
            <a:chOff x="3978700" y="574756"/>
            <a:chExt cx="2592147" cy="264786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F545A9B-4049-7D96-CB26-BC69E54485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91317" y="761772"/>
              <a:ext cx="2160000" cy="106582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FECB189-C4EE-3EE3-491C-7C66797B758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91317" y="2152608"/>
              <a:ext cx="2160000" cy="1065827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8A02B44-672C-A29C-494D-C566AC6AFB40}"/>
                </a:ext>
              </a:extLst>
            </p:cNvPr>
            <p:cNvSpPr txBox="1"/>
            <p:nvPr/>
          </p:nvSpPr>
          <p:spPr>
            <a:xfrm>
              <a:off x="4100463" y="574756"/>
              <a:ext cx="23298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i="1">
                  <a:latin typeface="Arial" panose="020B0604020202020204" pitchFamily="34" charset="0"/>
                  <a:cs typeface="Arial" panose="020B0604020202020204" pitchFamily="34" charset="0"/>
                </a:rPr>
                <a:t>lwd1 lwd2 pLWD1::LWD1-Venus</a:t>
              </a:r>
              <a:r>
                <a:rPr lang="en-US" sz="900" b="1">
                  <a:latin typeface="Arial" panose="020B0604020202020204" pitchFamily="34" charset="0"/>
                  <a:cs typeface="Arial" panose="020B0604020202020204" pitchFamily="34" charset="0"/>
                </a:rPr>
                <a:t> line1</a:t>
              </a:r>
              <a:endParaRPr lang="en-GB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1903E45-6D37-0557-6517-BA692A7CC916}"/>
                </a:ext>
              </a:extLst>
            </p:cNvPr>
            <p:cNvSpPr txBox="1"/>
            <p:nvPr/>
          </p:nvSpPr>
          <p:spPr>
            <a:xfrm>
              <a:off x="4100465" y="1964798"/>
              <a:ext cx="23044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/>
                <a:t>lwd1 lwd2 pLWD1::LWD1-Venus </a:t>
              </a:r>
              <a:r>
                <a:rPr lang="en-US" i="0"/>
                <a:t>line2</a:t>
              </a:r>
              <a:endParaRPr lang="en-GB" i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AE5204F-7422-DFD7-978E-8A24A81D1427}"/>
                </a:ext>
              </a:extLst>
            </p:cNvPr>
            <p:cNvSpPr txBox="1"/>
            <p:nvPr/>
          </p:nvSpPr>
          <p:spPr>
            <a:xfrm rot="16200000">
              <a:off x="3553508" y="1186963"/>
              <a:ext cx="10658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>
                  <a:latin typeface="Arial" panose="020B0604020202020204" pitchFamily="34" charset="0"/>
                  <a:cs typeface="Arial" panose="020B0604020202020204" pitchFamily="34" charset="0"/>
                </a:rPr>
                <a:t>Venu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417A678-63BE-832B-9815-1C025F23CA26}"/>
                </a:ext>
              </a:extLst>
            </p:cNvPr>
            <p:cNvSpPr txBox="1"/>
            <p:nvPr/>
          </p:nvSpPr>
          <p:spPr>
            <a:xfrm rot="16200000">
              <a:off x="3557654" y="2581981"/>
              <a:ext cx="10658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>
                  <a:latin typeface="Arial" panose="020B0604020202020204" pitchFamily="34" charset="0"/>
                  <a:cs typeface="Arial" panose="020B0604020202020204" pitchFamily="34" charset="0"/>
                </a:rPr>
                <a:t>Venus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E796CB8-7D24-16FF-77D5-B0DC7237D4F0}"/>
                </a:ext>
              </a:extLst>
            </p:cNvPr>
            <p:cNvSpPr txBox="1"/>
            <p:nvPr/>
          </p:nvSpPr>
          <p:spPr>
            <a:xfrm rot="16200000">
              <a:off x="5930211" y="1188208"/>
              <a:ext cx="10658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>
                  <a:latin typeface="Arial" panose="020B0604020202020204" pitchFamily="34" charset="0"/>
                  <a:cs typeface="Arial" panose="020B0604020202020204" pitchFamily="34" charset="0"/>
                </a:rPr>
                <a:t>Brightfield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E737C6A-42DB-CB6D-40BE-864BDFC04EF5}"/>
                </a:ext>
              </a:extLst>
            </p:cNvPr>
            <p:cNvSpPr txBox="1"/>
            <p:nvPr/>
          </p:nvSpPr>
          <p:spPr>
            <a:xfrm rot="16200000">
              <a:off x="5925655" y="2571564"/>
              <a:ext cx="10658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>
                  <a:latin typeface="Arial" panose="020B0604020202020204" pitchFamily="34" charset="0"/>
                  <a:cs typeface="Arial" panose="020B0604020202020204" pitchFamily="34" charset="0"/>
                </a:rPr>
                <a:t>Brightfield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25A98FDC-1430-4951-B8F7-DC89CC940123}"/>
              </a:ext>
            </a:extLst>
          </p:cNvPr>
          <p:cNvSpPr txBox="1"/>
          <p:nvPr/>
        </p:nvSpPr>
        <p:spPr>
          <a:xfrm>
            <a:off x="315256" y="596999"/>
            <a:ext cx="235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DEAC3B8-D282-5CB6-C943-6070B15DCA4E}"/>
              </a:ext>
            </a:extLst>
          </p:cNvPr>
          <p:cNvSpPr txBox="1"/>
          <p:nvPr/>
        </p:nvSpPr>
        <p:spPr>
          <a:xfrm>
            <a:off x="3611299" y="583345"/>
            <a:ext cx="235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Slide Number Placeholder 15">
            <a:extLst>
              <a:ext uri="{FF2B5EF4-FFF2-40B4-BE49-F238E27FC236}">
                <a16:creationId xmlns:a16="http://schemas.microsoft.com/office/drawing/2014/main" id="{C8B5EE98-7F1E-C643-AC5F-C9860539F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653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7</Words>
  <Application>Microsoft Macintosh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 Herrero Serrano</dc:creator>
  <cp:lastModifiedBy>Eva Herrero Serrano</cp:lastModifiedBy>
  <cp:revision>2</cp:revision>
  <cp:lastPrinted>2025-07-02T13:25:36Z</cp:lastPrinted>
  <dcterms:created xsi:type="dcterms:W3CDTF">2024-05-20T09:44:22Z</dcterms:created>
  <dcterms:modified xsi:type="dcterms:W3CDTF">2025-07-02T13:31:56Z</dcterms:modified>
</cp:coreProperties>
</file>